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  <p:sldId id="26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2"/>
    <p:restoredTop sz="94699"/>
  </p:normalViewPr>
  <p:slideViewPr>
    <p:cSldViewPr snapToGrid="0" snapToObjects="1">
      <p:cViewPr varScale="1">
        <p:scale>
          <a:sx n="112" d="100"/>
          <a:sy n="112" d="100"/>
        </p:scale>
        <p:origin x="158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036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87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155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419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15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88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563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218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472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544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265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977C-415E-4C4A-8A8E-91CA4E867DE1}" type="datetimeFigureOut">
              <a:rPr lang="en-US" smtClean="0"/>
              <a:t>2023-02-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2ECA0-5254-5C4D-AA08-35419F4B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48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783AAFE-25F8-344A-A532-EBA7DE5766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072" y="1980503"/>
            <a:ext cx="4534292" cy="26466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19234B2-46D4-0C4D-B88E-C2C514A589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65508" y="2070295"/>
            <a:ext cx="3264854" cy="266203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46029A6-ADB2-5143-95B1-419F2E8FA4D0}"/>
              </a:ext>
            </a:extLst>
          </p:cNvPr>
          <p:cNvSpPr txBox="1"/>
          <p:nvPr/>
        </p:nvSpPr>
        <p:spPr>
          <a:xfrm rot="16200000">
            <a:off x="898679" y="1261258"/>
            <a:ext cx="10682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Bt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IR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7539EF-434C-AA48-BC4E-8D6747E1FD76}"/>
              </a:ext>
            </a:extLst>
          </p:cNvPr>
          <p:cNvSpPr txBox="1"/>
          <p:nvPr/>
        </p:nvSpPr>
        <p:spPr>
          <a:xfrm rot="16200000">
            <a:off x="1217486" y="1099034"/>
            <a:ext cx="127134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Bt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IRE +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trept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agaros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50EBF8-F5C6-4E45-B413-9CB2355D7D0E}"/>
              </a:ext>
            </a:extLst>
          </p:cNvPr>
          <p:cNvSpPr txBox="1"/>
          <p:nvPr/>
        </p:nvSpPr>
        <p:spPr>
          <a:xfrm rot="16200000">
            <a:off x="300459" y="1040390"/>
            <a:ext cx="139635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o pre-clear  in this work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D17D41E-CD6C-B545-9DF5-2B74903892FA}"/>
              </a:ext>
            </a:extLst>
          </p:cNvPr>
          <p:cNvSpPr txBox="1"/>
          <p:nvPr/>
        </p:nvSpPr>
        <p:spPr>
          <a:xfrm>
            <a:off x="708877" y="24999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-cleare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C29E600-F5FB-744D-B4B0-19262CC84CD5}"/>
              </a:ext>
            </a:extLst>
          </p:cNvPr>
          <p:cNvSpPr txBox="1"/>
          <p:nvPr/>
        </p:nvSpPr>
        <p:spPr>
          <a:xfrm>
            <a:off x="848411" y="19042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BCA5615-1F9F-D340-BAEA-FA73D0700B87}"/>
              </a:ext>
            </a:extLst>
          </p:cNvPr>
          <p:cNvSpPr txBox="1"/>
          <p:nvPr/>
        </p:nvSpPr>
        <p:spPr>
          <a:xfrm>
            <a:off x="1300898" y="19042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88964AA-E7D0-7040-BAC1-2F60AA9541F5}"/>
              </a:ext>
            </a:extLst>
          </p:cNvPr>
          <p:cNvSpPr txBox="1"/>
          <p:nvPr/>
        </p:nvSpPr>
        <p:spPr>
          <a:xfrm>
            <a:off x="1725105" y="19042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1B9A5B2-025A-E043-A223-2E7CC388CCFB}"/>
              </a:ext>
            </a:extLst>
          </p:cNvPr>
          <p:cNvSpPr txBox="1"/>
          <p:nvPr/>
        </p:nvSpPr>
        <p:spPr>
          <a:xfrm>
            <a:off x="2113174" y="19042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9D753D9-3F23-BE4C-AC46-A3D793B02875}"/>
              </a:ext>
            </a:extLst>
          </p:cNvPr>
          <p:cNvSpPr txBox="1"/>
          <p:nvPr/>
        </p:nvSpPr>
        <p:spPr>
          <a:xfrm>
            <a:off x="2565661" y="19042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AD7A349-8C18-3F40-B0B4-C19468CBF04A}"/>
              </a:ext>
            </a:extLst>
          </p:cNvPr>
          <p:cNvSpPr txBox="1"/>
          <p:nvPr/>
        </p:nvSpPr>
        <p:spPr>
          <a:xfrm>
            <a:off x="2989868" y="19042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78959EE-0A96-D34F-B63D-AEF6CB0F7EDE}"/>
              </a:ext>
            </a:extLst>
          </p:cNvPr>
          <p:cNvSpPr txBox="1"/>
          <p:nvPr/>
        </p:nvSpPr>
        <p:spPr>
          <a:xfrm>
            <a:off x="2216870" y="1038598"/>
            <a:ext cx="9976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-cleared streptavidin-agarose  precipitate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3A5861D-12BB-F442-871E-C1B676DA6700}"/>
              </a:ext>
            </a:extLst>
          </p:cNvPr>
          <p:cNvSpPr txBox="1"/>
          <p:nvPr/>
        </p:nvSpPr>
        <p:spPr>
          <a:xfrm rot="16200000">
            <a:off x="2868571" y="1207072"/>
            <a:ext cx="13548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562 WCL (4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8F3A62F-2804-7743-85E3-FC9C8DC67B43}"/>
              </a:ext>
            </a:extLst>
          </p:cNvPr>
          <p:cNvSpPr txBox="1"/>
          <p:nvPr/>
        </p:nvSpPr>
        <p:spPr>
          <a:xfrm rot="16200000">
            <a:off x="4053716" y="1586275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RP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F9AC48D-8D80-4144-AE45-B4FDC34F06B5}"/>
              </a:ext>
            </a:extLst>
          </p:cNvPr>
          <p:cNvSpPr txBox="1"/>
          <p:nvPr/>
        </p:nvSpPr>
        <p:spPr>
          <a:xfrm rot="16200000">
            <a:off x="4413505" y="158784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RP1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CA32E4B-10E1-824C-94EC-0235734EDE8D}"/>
              </a:ext>
            </a:extLst>
          </p:cNvPr>
          <p:cNvCxnSpPr>
            <a:cxnSpLocks/>
          </p:cNvCxnSpPr>
          <p:nvPr/>
        </p:nvCxnSpPr>
        <p:spPr>
          <a:xfrm>
            <a:off x="860980" y="1935715"/>
            <a:ext cx="11940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870DF1F-2706-E64A-B423-A2E97AC97FD4}"/>
              </a:ext>
            </a:extLst>
          </p:cNvPr>
          <p:cNvCxnSpPr>
            <a:cxnSpLocks/>
          </p:cNvCxnSpPr>
          <p:nvPr/>
        </p:nvCxnSpPr>
        <p:spPr>
          <a:xfrm>
            <a:off x="2097462" y="1927859"/>
            <a:ext cx="11940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D42DAE9B-BBA1-9B45-8C9B-2BE76806728C}"/>
              </a:ext>
            </a:extLst>
          </p:cNvPr>
          <p:cNvSpPr txBox="1"/>
          <p:nvPr/>
        </p:nvSpPr>
        <p:spPr>
          <a:xfrm rot="16200000">
            <a:off x="-337381" y="978042"/>
            <a:ext cx="17273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e-clear WCL with: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3862B6C-E250-F947-9D45-A469C02F0B28}"/>
              </a:ext>
            </a:extLst>
          </p:cNvPr>
          <p:cNvSpPr txBox="1"/>
          <p:nvPr/>
        </p:nvSpPr>
        <p:spPr>
          <a:xfrm>
            <a:off x="9306" y="195142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7E33833-9CBF-DE4E-86DA-A0B5ADAE84A6}"/>
              </a:ext>
            </a:extLst>
          </p:cNvPr>
          <p:cNvSpPr txBox="1"/>
          <p:nvPr/>
        </p:nvSpPr>
        <p:spPr>
          <a:xfrm>
            <a:off x="9306" y="226250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41FAB15-6991-A246-B900-B4BCA82898FA}"/>
              </a:ext>
            </a:extLst>
          </p:cNvPr>
          <p:cNvSpPr txBox="1"/>
          <p:nvPr/>
        </p:nvSpPr>
        <p:spPr>
          <a:xfrm>
            <a:off x="94266" y="251703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E295426-F52B-DF44-AF28-58BF76D7AF05}"/>
              </a:ext>
            </a:extLst>
          </p:cNvPr>
          <p:cNvSpPr txBox="1"/>
          <p:nvPr/>
        </p:nvSpPr>
        <p:spPr>
          <a:xfrm>
            <a:off x="94266" y="309206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7D98B1D-6354-C943-BB0A-EC97074CCF82}"/>
              </a:ext>
            </a:extLst>
          </p:cNvPr>
          <p:cNvSpPr txBox="1"/>
          <p:nvPr/>
        </p:nvSpPr>
        <p:spPr>
          <a:xfrm>
            <a:off x="94266" y="360111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B786732-0625-2449-8706-540E352E362D}"/>
              </a:ext>
            </a:extLst>
          </p:cNvPr>
          <p:cNvSpPr txBox="1"/>
          <p:nvPr/>
        </p:nvSpPr>
        <p:spPr>
          <a:xfrm>
            <a:off x="94266" y="43552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7A3B4C9-BF22-9D44-9DDC-5DA71BCEFC64}"/>
              </a:ext>
            </a:extLst>
          </p:cNvPr>
          <p:cNvSpPr txBox="1"/>
          <p:nvPr/>
        </p:nvSpPr>
        <p:spPr>
          <a:xfrm>
            <a:off x="5327595" y="200013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40B6676-2455-0E45-A226-0D65DEAE6150}"/>
              </a:ext>
            </a:extLst>
          </p:cNvPr>
          <p:cNvSpPr txBox="1"/>
          <p:nvPr/>
        </p:nvSpPr>
        <p:spPr>
          <a:xfrm>
            <a:off x="5327595" y="23112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DE4C6EE-6A31-1E4A-A575-F9A4111AC809}"/>
              </a:ext>
            </a:extLst>
          </p:cNvPr>
          <p:cNvSpPr txBox="1"/>
          <p:nvPr/>
        </p:nvSpPr>
        <p:spPr>
          <a:xfrm>
            <a:off x="5412555" y="25657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8B92181-5120-114D-B68D-4865A0721457}"/>
              </a:ext>
            </a:extLst>
          </p:cNvPr>
          <p:cNvSpPr txBox="1"/>
          <p:nvPr/>
        </p:nvSpPr>
        <p:spPr>
          <a:xfrm>
            <a:off x="5412555" y="31407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CF3CBF5-F4C6-6C41-8C8D-07163FB31B27}"/>
              </a:ext>
            </a:extLst>
          </p:cNvPr>
          <p:cNvSpPr txBox="1"/>
          <p:nvPr/>
        </p:nvSpPr>
        <p:spPr>
          <a:xfrm>
            <a:off x="5412555" y="36498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40DDFBA-6572-5341-85EB-D53379521B46}"/>
              </a:ext>
            </a:extLst>
          </p:cNvPr>
          <p:cNvSpPr txBox="1"/>
          <p:nvPr/>
        </p:nvSpPr>
        <p:spPr>
          <a:xfrm>
            <a:off x="5412555" y="44039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62054D3-07DF-B842-84BA-0BE4A2E71965}"/>
              </a:ext>
            </a:extLst>
          </p:cNvPr>
          <p:cNvSpPr txBox="1"/>
          <p:nvPr/>
        </p:nvSpPr>
        <p:spPr>
          <a:xfrm>
            <a:off x="661448" y="369293"/>
            <a:ext cx="1625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ull-down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tIR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52BA8B2-2CC2-7D48-848A-019F694CFD7E}"/>
              </a:ext>
            </a:extLst>
          </p:cNvPr>
          <p:cNvCxnSpPr>
            <a:cxnSpLocks/>
          </p:cNvCxnSpPr>
          <p:nvPr/>
        </p:nvCxnSpPr>
        <p:spPr>
          <a:xfrm>
            <a:off x="796564" y="655241"/>
            <a:ext cx="11940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18446016-8166-C74F-9B54-CDB750490C9B}"/>
              </a:ext>
            </a:extLst>
          </p:cNvPr>
          <p:cNvSpPr txBox="1"/>
          <p:nvPr/>
        </p:nvSpPr>
        <p:spPr>
          <a:xfrm>
            <a:off x="713653" y="214721"/>
            <a:ext cx="15119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562 WCL (100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97FD061-00BB-264E-80D6-9C399A627DCA}"/>
              </a:ext>
            </a:extLst>
          </p:cNvPr>
          <p:cNvSpPr txBox="1"/>
          <p:nvPr/>
        </p:nvSpPr>
        <p:spPr>
          <a:xfrm rot="16200000">
            <a:off x="3157978" y="848487"/>
            <a:ext cx="1132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1/25 of input)</a:t>
            </a:r>
          </a:p>
        </p:txBody>
      </p:sp>
      <p:sp>
        <p:nvSpPr>
          <p:cNvPr id="56" name="Triangle 55">
            <a:extLst>
              <a:ext uri="{FF2B5EF4-FFF2-40B4-BE49-F238E27FC236}">
                <a16:creationId xmlns:a16="http://schemas.microsoft.com/office/drawing/2014/main" id="{13D2D20D-F658-A346-8316-719E106B9A31}"/>
              </a:ext>
            </a:extLst>
          </p:cNvPr>
          <p:cNvSpPr/>
          <p:nvPr/>
        </p:nvSpPr>
        <p:spPr>
          <a:xfrm rot="16200000">
            <a:off x="4878370" y="2418050"/>
            <a:ext cx="146115" cy="127262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787EF32-68A7-E140-A308-DE1DE345E0F4}"/>
              </a:ext>
            </a:extLst>
          </p:cNvPr>
          <p:cNvSpPr txBox="1"/>
          <p:nvPr/>
        </p:nvSpPr>
        <p:spPr>
          <a:xfrm>
            <a:off x="4967925" y="234735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RP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B77A199-DE8D-764C-BE00-53479EAEDC55}"/>
              </a:ext>
            </a:extLst>
          </p:cNvPr>
          <p:cNvSpPr txBox="1"/>
          <p:nvPr/>
        </p:nvSpPr>
        <p:spPr>
          <a:xfrm>
            <a:off x="257575" y="4589598"/>
            <a:ext cx="48224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Pull-down pre-cleared WCLs with biotinyla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IRE followed by western blotting with anti-IRP2 antibody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64F0F8-1F4A-7E44-9C12-4006AEA01277}"/>
              </a:ext>
            </a:extLst>
          </p:cNvPr>
          <p:cNvSpPr txBox="1"/>
          <p:nvPr/>
        </p:nvSpPr>
        <p:spPr>
          <a:xfrm>
            <a:off x="5344611" y="4672839"/>
            <a:ext cx="37993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B) Staining the PVDF membrane with Coomassie brilliant blue G-250 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D9741AF-FE72-2E4F-BCE1-3333BAE8E6F8}"/>
              </a:ext>
            </a:extLst>
          </p:cNvPr>
          <p:cNvSpPr txBox="1"/>
          <p:nvPr/>
        </p:nvSpPr>
        <p:spPr>
          <a:xfrm rot="16200000">
            <a:off x="6104767" y="1225122"/>
            <a:ext cx="10682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Bt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IR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3C1E73A-1793-C246-ACE3-46C87664900F}"/>
              </a:ext>
            </a:extLst>
          </p:cNvPr>
          <p:cNvSpPr txBox="1"/>
          <p:nvPr/>
        </p:nvSpPr>
        <p:spPr>
          <a:xfrm rot="16200000">
            <a:off x="6423574" y="1062898"/>
            <a:ext cx="127134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Bt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IRE +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trept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agarose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C81464E-17AB-FE46-98F3-056A644166B3}"/>
              </a:ext>
            </a:extLst>
          </p:cNvPr>
          <p:cNvSpPr txBox="1"/>
          <p:nvPr/>
        </p:nvSpPr>
        <p:spPr>
          <a:xfrm rot="16200000">
            <a:off x="5511034" y="1008741"/>
            <a:ext cx="138737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-eclea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in this work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488B833-74D4-E947-AC38-92D9005D0209}"/>
              </a:ext>
            </a:extLst>
          </p:cNvPr>
          <p:cNvSpPr txBox="1"/>
          <p:nvPr/>
        </p:nvSpPr>
        <p:spPr>
          <a:xfrm>
            <a:off x="5913097" y="0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-cleare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0C748B2-A657-9744-A343-51B09E01B79F}"/>
              </a:ext>
            </a:extLst>
          </p:cNvPr>
          <p:cNvSpPr txBox="1"/>
          <p:nvPr/>
        </p:nvSpPr>
        <p:spPr>
          <a:xfrm>
            <a:off x="6054499" y="18681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B964546-3623-E947-ADA9-A3F0CD226D75}"/>
              </a:ext>
            </a:extLst>
          </p:cNvPr>
          <p:cNvSpPr txBox="1"/>
          <p:nvPr/>
        </p:nvSpPr>
        <p:spPr>
          <a:xfrm>
            <a:off x="6506986" y="18681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A551D24-1588-9C49-837D-06F30BCF3C2B}"/>
              </a:ext>
            </a:extLst>
          </p:cNvPr>
          <p:cNvSpPr txBox="1"/>
          <p:nvPr/>
        </p:nvSpPr>
        <p:spPr>
          <a:xfrm>
            <a:off x="6931193" y="18681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6A35D44-0899-3A47-A3E7-7FD9509DB67E}"/>
              </a:ext>
            </a:extLst>
          </p:cNvPr>
          <p:cNvSpPr txBox="1"/>
          <p:nvPr/>
        </p:nvSpPr>
        <p:spPr>
          <a:xfrm>
            <a:off x="7347543" y="18681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57302A0-CADC-AB4E-B0E7-2E928C9B033C}"/>
              </a:ext>
            </a:extLst>
          </p:cNvPr>
          <p:cNvSpPr txBox="1"/>
          <p:nvPr/>
        </p:nvSpPr>
        <p:spPr>
          <a:xfrm>
            <a:off x="7724614" y="18681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C29C2BD-3A4E-5740-95FB-7B0804C50010}"/>
              </a:ext>
            </a:extLst>
          </p:cNvPr>
          <p:cNvSpPr txBox="1"/>
          <p:nvPr/>
        </p:nvSpPr>
        <p:spPr>
          <a:xfrm>
            <a:off x="8148821" y="18681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E43019B-67A8-8E41-8444-45BE78743B96}"/>
              </a:ext>
            </a:extLst>
          </p:cNvPr>
          <p:cNvSpPr txBox="1"/>
          <p:nvPr/>
        </p:nvSpPr>
        <p:spPr>
          <a:xfrm>
            <a:off x="7375823" y="1002462"/>
            <a:ext cx="9976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-cleared streptavidin-agarose  precipitate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AFC2EA3-476B-F745-B3D4-2E9C63F0CE94}"/>
              </a:ext>
            </a:extLst>
          </p:cNvPr>
          <p:cNvSpPr txBox="1"/>
          <p:nvPr/>
        </p:nvSpPr>
        <p:spPr>
          <a:xfrm rot="16200000">
            <a:off x="7970962" y="1226002"/>
            <a:ext cx="13548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562 WCL (4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0687C971-B150-154D-B2DA-8A190A3D9E22}"/>
              </a:ext>
            </a:extLst>
          </p:cNvPr>
          <p:cNvCxnSpPr>
            <a:cxnSpLocks/>
          </p:cNvCxnSpPr>
          <p:nvPr/>
        </p:nvCxnSpPr>
        <p:spPr>
          <a:xfrm>
            <a:off x="6019933" y="1899579"/>
            <a:ext cx="11940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576001C7-5602-6A45-82F8-BED79137E9AD}"/>
              </a:ext>
            </a:extLst>
          </p:cNvPr>
          <p:cNvCxnSpPr>
            <a:cxnSpLocks/>
          </p:cNvCxnSpPr>
          <p:nvPr/>
        </p:nvCxnSpPr>
        <p:spPr>
          <a:xfrm>
            <a:off x="7256415" y="1891723"/>
            <a:ext cx="11940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73B898FA-989C-1143-AAE6-F5C3D83D60F7}"/>
              </a:ext>
            </a:extLst>
          </p:cNvPr>
          <p:cNvSpPr txBox="1"/>
          <p:nvPr/>
        </p:nvSpPr>
        <p:spPr>
          <a:xfrm rot="16200000">
            <a:off x="4821572" y="941906"/>
            <a:ext cx="17273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e-clear WCL with: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040FFCF-7F39-1F4A-BDD3-D4292800D324}"/>
              </a:ext>
            </a:extLst>
          </p:cNvPr>
          <p:cNvSpPr txBox="1"/>
          <p:nvPr/>
        </p:nvSpPr>
        <p:spPr>
          <a:xfrm>
            <a:off x="5820401" y="333157"/>
            <a:ext cx="1625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ull-down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tIR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DC8FD6AC-A624-F74F-89E6-595DA07F2575}"/>
              </a:ext>
            </a:extLst>
          </p:cNvPr>
          <p:cNvCxnSpPr>
            <a:cxnSpLocks/>
          </p:cNvCxnSpPr>
          <p:nvPr/>
        </p:nvCxnSpPr>
        <p:spPr>
          <a:xfrm>
            <a:off x="5955517" y="619105"/>
            <a:ext cx="11940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454A2414-2AC0-D745-B207-E8114BBDEC70}"/>
              </a:ext>
            </a:extLst>
          </p:cNvPr>
          <p:cNvSpPr txBox="1"/>
          <p:nvPr/>
        </p:nvSpPr>
        <p:spPr>
          <a:xfrm>
            <a:off x="5908820" y="178585"/>
            <a:ext cx="15119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562 WCL (100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C8F3E94-7BAD-4B47-8CC5-BC3B634A6659}"/>
              </a:ext>
            </a:extLst>
          </p:cNvPr>
          <p:cNvSpPr txBox="1"/>
          <p:nvPr/>
        </p:nvSpPr>
        <p:spPr>
          <a:xfrm rot="16200000">
            <a:off x="8260369" y="812351"/>
            <a:ext cx="1132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1/25 of input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4B89A25-8C1A-3542-B772-6AE1FC3E74A8}"/>
              </a:ext>
            </a:extLst>
          </p:cNvPr>
          <p:cNvSpPr txBox="1"/>
          <p:nvPr/>
        </p:nvSpPr>
        <p:spPr>
          <a:xfrm>
            <a:off x="0" y="4355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15A4387-8C33-C146-B6DA-992F90E6F909}"/>
              </a:ext>
            </a:extLst>
          </p:cNvPr>
          <p:cNvSpPr txBox="1"/>
          <p:nvPr/>
        </p:nvSpPr>
        <p:spPr>
          <a:xfrm>
            <a:off x="4978924" y="4355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279EB11-B194-7C44-8F7B-C95FBF0EC7EA}"/>
              </a:ext>
            </a:extLst>
          </p:cNvPr>
          <p:cNvSpPr/>
          <p:nvPr/>
        </p:nvSpPr>
        <p:spPr>
          <a:xfrm>
            <a:off x="76954" y="5401481"/>
            <a:ext cx="897651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(A) 1 mg of K562 WCLs were first pre-cleared with none (1, no preclear was the condition used throughout this paper), 5 </a:t>
            </a:r>
            <a:r>
              <a:rPr lang="el-G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g biotinylated mutant IRE (2), or 5 </a:t>
            </a:r>
            <a:r>
              <a:rPr lang="el-G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g biotinylated mutant IRE plus 20 </a:t>
            </a:r>
            <a:r>
              <a:rPr lang="el-G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L streptavidin agarose (3) for 1 hr. After all three samples were incubated with 20 </a:t>
            </a:r>
            <a:r>
              <a:rPr lang="el-G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L streptavidin agarose for 15 min, the precleared WCLs were subjected to the pull-down procedure optimized in this work; they were incubated with 2 </a:t>
            </a:r>
            <a:r>
              <a:rPr lang="el-G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g biotinylated wild type IRE, performed pull-down with 20 </a:t>
            </a:r>
            <a:r>
              <a:rPr lang="el-G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L streptavidin agarose, and western blotting with an anti-IRP2 antibody. The precleared precipitates with streptavidin-agarose for 15 min were also loaded. (B) The PVDF membrane was stained with Coomassie G-250. </a:t>
            </a:r>
            <a:endParaRPr lang="en-US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7A52A4-6CA2-5A43-B018-0FC3857B838D}"/>
              </a:ext>
            </a:extLst>
          </p:cNvPr>
          <p:cNvSpPr txBox="1"/>
          <p:nvPr/>
        </p:nvSpPr>
        <p:spPr>
          <a:xfrm>
            <a:off x="81481" y="5178587"/>
            <a:ext cx="8566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1: </a:t>
            </a:r>
            <a:r>
              <a:rPr lang="en-US" sz="1200" b="1" dirty="0">
                <a:latin typeface="Palatino Linotype" panose="02040502050505030304" pitchFamily="18" charset="0"/>
              </a:rPr>
              <a:t>Pre-clearing whole cell lysates (WCLs) with biotinylated mutant IRE and streptavidin agarose</a:t>
            </a:r>
            <a:r>
              <a:rPr lang="en-US" sz="1200" dirty="0">
                <a:latin typeface="Palatino Linotype" panose="02040502050505030304" pitchFamily="18" charset="0"/>
              </a:rPr>
              <a:t> </a:t>
            </a:r>
            <a:endParaRPr lang="en-US" sz="12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D0BAF8F-AE1C-BD44-9073-9FC87BDACCD2}"/>
              </a:ext>
            </a:extLst>
          </p:cNvPr>
          <p:cNvCxnSpPr>
            <a:cxnSpLocks/>
          </p:cNvCxnSpPr>
          <p:nvPr/>
        </p:nvCxnSpPr>
        <p:spPr>
          <a:xfrm flipV="1">
            <a:off x="3953766" y="1747650"/>
            <a:ext cx="0" cy="131826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875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0F4A1EE-CD87-7947-848E-19637CD1EAF7}"/>
              </a:ext>
            </a:extLst>
          </p:cNvPr>
          <p:cNvSpPr txBox="1"/>
          <p:nvPr/>
        </p:nvSpPr>
        <p:spPr>
          <a:xfrm>
            <a:off x="1697357" y="4884385"/>
            <a:ext cx="58592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</a:t>
            </a:r>
            <a:r>
              <a:rPr lang="en-US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2: Performance of two Nrf2 antibodies in western blotting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AF5B4D0-BEE5-9B4D-B558-E9382369C9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1169" y="611754"/>
            <a:ext cx="4036290" cy="190009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D944B0C-8F0E-574D-8994-378A6A2A1C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0407" y="2594855"/>
            <a:ext cx="4029801" cy="189703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3FCD491-E068-9F49-9744-A3125FD4850E}"/>
              </a:ext>
            </a:extLst>
          </p:cNvPr>
          <p:cNvSpPr txBox="1"/>
          <p:nvPr/>
        </p:nvSpPr>
        <p:spPr>
          <a:xfrm rot="16200000">
            <a:off x="2107278" y="196337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6FD885-303D-C44D-B83E-8CBC41869C13}"/>
              </a:ext>
            </a:extLst>
          </p:cNvPr>
          <p:cNvSpPr txBox="1"/>
          <p:nvPr/>
        </p:nvSpPr>
        <p:spPr>
          <a:xfrm rot="16200000">
            <a:off x="2485971" y="19152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46FD03-5952-1B4D-9745-0F3B9721229C}"/>
              </a:ext>
            </a:extLst>
          </p:cNvPr>
          <p:cNvSpPr txBox="1"/>
          <p:nvPr/>
        </p:nvSpPr>
        <p:spPr>
          <a:xfrm>
            <a:off x="4134659" y="59876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D90ABC-DC59-C041-8773-F96DD2744043}"/>
              </a:ext>
            </a:extLst>
          </p:cNvPr>
          <p:cNvSpPr txBox="1"/>
          <p:nvPr/>
        </p:nvSpPr>
        <p:spPr>
          <a:xfrm>
            <a:off x="4139277" y="8804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AC28FB7-6CCC-A44C-8500-A41865F43A41}"/>
              </a:ext>
            </a:extLst>
          </p:cNvPr>
          <p:cNvSpPr txBox="1"/>
          <p:nvPr/>
        </p:nvSpPr>
        <p:spPr>
          <a:xfrm>
            <a:off x="4208549" y="120836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B086FD-77EF-104F-9573-75E428134401}"/>
              </a:ext>
            </a:extLst>
          </p:cNvPr>
          <p:cNvSpPr txBox="1"/>
          <p:nvPr/>
        </p:nvSpPr>
        <p:spPr>
          <a:xfrm rot="16200000">
            <a:off x="2850806" y="19152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3412F7-89DB-EE47-B998-C492B763347A}"/>
              </a:ext>
            </a:extLst>
          </p:cNvPr>
          <p:cNvSpPr txBox="1"/>
          <p:nvPr/>
        </p:nvSpPr>
        <p:spPr>
          <a:xfrm rot="16200000">
            <a:off x="3224880" y="19152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F0695F8-1E03-BC43-92A5-D316C1EC7A4C}"/>
              </a:ext>
            </a:extLst>
          </p:cNvPr>
          <p:cNvSpPr txBox="1"/>
          <p:nvPr/>
        </p:nvSpPr>
        <p:spPr>
          <a:xfrm rot="16200000">
            <a:off x="3580480" y="19152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69B38A-DDF7-B54E-ABAE-52EF25D27105}"/>
              </a:ext>
            </a:extLst>
          </p:cNvPr>
          <p:cNvSpPr txBox="1"/>
          <p:nvPr/>
        </p:nvSpPr>
        <p:spPr>
          <a:xfrm>
            <a:off x="4222403" y="15916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77B6D7-68CC-5046-9C35-A2FA17D71672}"/>
              </a:ext>
            </a:extLst>
          </p:cNvPr>
          <p:cNvSpPr txBox="1"/>
          <p:nvPr/>
        </p:nvSpPr>
        <p:spPr>
          <a:xfrm>
            <a:off x="4227021" y="20673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C1E41F3-6535-D94D-8FCF-352995F9FE4D}"/>
              </a:ext>
            </a:extLst>
          </p:cNvPr>
          <p:cNvSpPr txBox="1"/>
          <p:nvPr/>
        </p:nvSpPr>
        <p:spPr>
          <a:xfrm rot="16200000">
            <a:off x="4467171" y="186910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C632C85-4A95-6D41-AD21-1CD308C214A1}"/>
              </a:ext>
            </a:extLst>
          </p:cNvPr>
          <p:cNvSpPr txBox="1"/>
          <p:nvPr/>
        </p:nvSpPr>
        <p:spPr>
          <a:xfrm rot="16200000">
            <a:off x="4832006" y="186910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581C618-9A5E-6A4D-83CB-C4E1AB9D2A14}"/>
              </a:ext>
            </a:extLst>
          </p:cNvPr>
          <p:cNvSpPr txBox="1"/>
          <p:nvPr/>
        </p:nvSpPr>
        <p:spPr>
          <a:xfrm rot="16200000">
            <a:off x="5206080" y="186910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749BE5-EF9B-EB43-80CD-DB1367964B21}"/>
              </a:ext>
            </a:extLst>
          </p:cNvPr>
          <p:cNvSpPr txBox="1"/>
          <p:nvPr/>
        </p:nvSpPr>
        <p:spPr>
          <a:xfrm rot="16200000">
            <a:off x="5561680" y="186910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rf2-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9552845-4D08-2343-8357-32AD94601093}"/>
              </a:ext>
            </a:extLst>
          </p:cNvPr>
          <p:cNvSpPr txBox="1"/>
          <p:nvPr/>
        </p:nvSpPr>
        <p:spPr>
          <a:xfrm>
            <a:off x="4111568" y="42789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775A8FC-3445-DF4F-9720-C273383FF928}"/>
              </a:ext>
            </a:extLst>
          </p:cNvPr>
          <p:cNvSpPr txBox="1"/>
          <p:nvPr/>
        </p:nvSpPr>
        <p:spPr>
          <a:xfrm>
            <a:off x="2338188" y="4438491"/>
            <a:ext cx="1826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ti-Nrf2 (D129C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6E642DE-51DD-8E4B-A3B9-54E765B8B4EB}"/>
              </a:ext>
            </a:extLst>
          </p:cNvPr>
          <p:cNvSpPr txBox="1"/>
          <p:nvPr/>
        </p:nvSpPr>
        <p:spPr>
          <a:xfrm>
            <a:off x="4356334" y="4452346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ti-Nrf2 (SC-13032x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67002CC-E44E-8B4B-A46C-475BFC113AFB}"/>
              </a:ext>
            </a:extLst>
          </p:cNvPr>
          <p:cNvSpPr txBox="1"/>
          <p:nvPr/>
        </p:nvSpPr>
        <p:spPr>
          <a:xfrm>
            <a:off x="6235392" y="3651485"/>
            <a:ext cx="130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onger exposur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6473DC6-9667-0F4F-AC19-446031F83031}"/>
              </a:ext>
            </a:extLst>
          </p:cNvPr>
          <p:cNvSpPr txBox="1"/>
          <p:nvPr/>
        </p:nvSpPr>
        <p:spPr>
          <a:xfrm>
            <a:off x="6343757" y="70125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</a:p>
        </p:txBody>
      </p:sp>
      <p:sp>
        <p:nvSpPr>
          <p:cNvPr id="34" name="Triangle 33">
            <a:extLst>
              <a:ext uri="{FF2B5EF4-FFF2-40B4-BE49-F238E27FC236}">
                <a16:creationId xmlns:a16="http://schemas.microsoft.com/office/drawing/2014/main" id="{333928F1-56EC-064D-8352-107E4AE1B344}"/>
              </a:ext>
            </a:extLst>
          </p:cNvPr>
          <p:cNvSpPr/>
          <p:nvPr/>
        </p:nvSpPr>
        <p:spPr>
          <a:xfrm rot="1780139">
            <a:off x="6285574" y="813751"/>
            <a:ext cx="138083" cy="119784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C1F4BAB-5D0E-E743-A5A7-0C41C04C5086}"/>
              </a:ext>
            </a:extLst>
          </p:cNvPr>
          <p:cNvSpPr txBox="1"/>
          <p:nvPr/>
        </p:nvSpPr>
        <p:spPr>
          <a:xfrm>
            <a:off x="6366848" y="271940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</a:p>
        </p:txBody>
      </p:sp>
      <p:sp>
        <p:nvSpPr>
          <p:cNvPr id="36" name="Triangle 35">
            <a:extLst>
              <a:ext uri="{FF2B5EF4-FFF2-40B4-BE49-F238E27FC236}">
                <a16:creationId xmlns:a16="http://schemas.microsoft.com/office/drawing/2014/main" id="{250A4282-23C8-9048-8466-03A2379F2BFA}"/>
              </a:ext>
            </a:extLst>
          </p:cNvPr>
          <p:cNvSpPr/>
          <p:nvPr/>
        </p:nvSpPr>
        <p:spPr>
          <a:xfrm rot="1780139">
            <a:off x="6308665" y="2831897"/>
            <a:ext cx="138083" cy="119784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48B0776-5136-6248-B70F-0B2738C50328}"/>
              </a:ext>
            </a:extLst>
          </p:cNvPr>
          <p:cNvSpPr txBox="1"/>
          <p:nvPr/>
        </p:nvSpPr>
        <p:spPr>
          <a:xfrm>
            <a:off x="2324333" y="4674935"/>
            <a:ext cx="19143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Cell Signaling Technology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7A890EC-7A56-9A45-9777-6F05DA26E1A1}"/>
              </a:ext>
            </a:extLst>
          </p:cNvPr>
          <p:cNvSpPr txBox="1"/>
          <p:nvPr/>
        </p:nvSpPr>
        <p:spPr>
          <a:xfrm>
            <a:off x="4536441" y="4670316"/>
            <a:ext cx="19094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Santa Cruz Biotechnology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31864EF-AC66-C846-BF77-FB1AD6E8F589}"/>
              </a:ext>
            </a:extLst>
          </p:cNvPr>
          <p:cNvSpPr txBox="1"/>
          <p:nvPr/>
        </p:nvSpPr>
        <p:spPr>
          <a:xfrm>
            <a:off x="1712952" y="5103674"/>
            <a:ext cx="562035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30 </a:t>
            </a:r>
            <a:r>
              <a:rPr lang="el-G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μ</a:t>
            </a:r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g of whole cell lysates from HEK293 cells transfected with </a:t>
            </a:r>
            <a:r>
              <a:rPr lang="en-US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CMV</a:t>
            </a:r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vector and pCMVNrf2 (4 independently transfected samples) were loaded on 10% acrylamide SDS-PAGE gel and subjected to western blotting. The left membrane was incubated with 1,000-fold diluted anti-Nrf2 antibody (D129C, in 5% skim milk in Tween20/TBS), and the right membrane was incubated with 1,500-fold diluted anti-Nrf2 (SC-13032x, in 5% skim milk in Tween20/TBS) at 4</a:t>
            </a:r>
            <a:r>
              <a:rPr lang="en-US" sz="12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o</a:t>
            </a:r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C overnight. Both membranes were incubated with 5,000-fold diluted anti-rabbit IgG-HRP at room temperature </a:t>
            </a:r>
            <a:r>
              <a:rPr lang="en-US" sz="1200">
                <a:latin typeface="Palatino Linotype" panose="02040502050505030304" pitchFamily="18" charset="0"/>
                <a:cs typeface="Arial" panose="020B0604020202020204" pitchFamily="34" charset="0"/>
              </a:rPr>
              <a:t>for 1.5 hr</a:t>
            </a:r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nd ECL detection (Pierce 32106). </a:t>
            </a:r>
          </a:p>
          <a:p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The lower panel shows a longer exposed result.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8C10CBA8-8EB6-3B4C-B342-FE07C44633C7}"/>
              </a:ext>
            </a:extLst>
          </p:cNvPr>
          <p:cNvCxnSpPr>
            <a:cxnSpLocks/>
          </p:cNvCxnSpPr>
          <p:nvPr/>
        </p:nvCxnSpPr>
        <p:spPr>
          <a:xfrm>
            <a:off x="4324408" y="249591"/>
            <a:ext cx="0" cy="2265318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29D1684-2D22-C54F-A41F-00160D1D85B6}"/>
              </a:ext>
            </a:extLst>
          </p:cNvPr>
          <p:cNvCxnSpPr>
            <a:cxnSpLocks/>
            <a:endCxn id="30" idx="1"/>
          </p:cNvCxnSpPr>
          <p:nvPr/>
        </p:nvCxnSpPr>
        <p:spPr>
          <a:xfrm>
            <a:off x="4317782" y="2475764"/>
            <a:ext cx="38552" cy="2145859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153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73</Words>
  <Application>Microsoft Office PowerPoint</Application>
  <PresentationFormat>On-screen Show (4:3)</PresentationFormat>
  <Paragraphs>7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DPI</cp:lastModifiedBy>
  <cp:revision>3</cp:revision>
  <dcterms:created xsi:type="dcterms:W3CDTF">2023-02-09T14:28:20Z</dcterms:created>
  <dcterms:modified xsi:type="dcterms:W3CDTF">2023-02-10T11:55:43Z</dcterms:modified>
</cp:coreProperties>
</file>